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56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7015" autoAdjust="0"/>
    <p:restoredTop sz="94660"/>
  </p:normalViewPr>
  <p:slideViewPr>
    <p:cSldViewPr snapToGrid="0" showGuides="1">
      <p:cViewPr varScale="1">
        <p:scale>
          <a:sx n="75" d="100"/>
          <a:sy n="75" d="100"/>
        </p:scale>
        <p:origin x="3012" y="84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s-ES"/>
              <a:t>Haga clic para editar el estilo de subtítulo del patró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82BCF9-E21E-4A59-89A9-04EA4039B66B}" type="datetimeFigureOut">
              <a:rPr lang="es-ES" smtClean="0"/>
              <a:t>31/10/2025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7052A2-6A4C-4995-BC0D-3073A0A27D54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88903060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82BCF9-E21E-4A59-89A9-04EA4039B66B}" type="datetimeFigureOut">
              <a:rPr lang="es-ES" smtClean="0"/>
              <a:t>31/10/2025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7052A2-6A4C-4995-BC0D-3073A0A27D54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81181182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82BCF9-E21E-4A59-89A9-04EA4039B66B}" type="datetimeFigureOut">
              <a:rPr lang="es-ES" smtClean="0"/>
              <a:t>31/10/2025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7052A2-6A4C-4995-BC0D-3073A0A27D54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43576092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82BCF9-E21E-4A59-89A9-04EA4039B66B}" type="datetimeFigureOut">
              <a:rPr lang="es-ES" smtClean="0"/>
              <a:t>31/10/2025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7052A2-6A4C-4995-BC0D-3073A0A27D54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48693830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/>
              <a:t>Editar el estilo de texto del patró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82BCF9-E21E-4A59-89A9-04EA4039B66B}" type="datetimeFigureOut">
              <a:rPr lang="es-ES" smtClean="0"/>
              <a:t>31/10/2025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7052A2-6A4C-4995-BC0D-3073A0A27D54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85159892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82BCF9-E21E-4A59-89A9-04EA4039B66B}" type="datetimeFigureOut">
              <a:rPr lang="es-ES" smtClean="0"/>
              <a:t>31/10/2025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7052A2-6A4C-4995-BC0D-3073A0A27D54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0470076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s-ES"/>
              <a:t>Editar el estilo de texto del patró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s-ES"/>
              <a:t>Editar el estilo de texto del patró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82BCF9-E21E-4A59-89A9-04EA4039B66B}" type="datetimeFigureOut">
              <a:rPr lang="es-ES" smtClean="0"/>
              <a:t>31/10/2025</a:t>
            </a:fld>
            <a:endParaRPr lang="es-E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7052A2-6A4C-4995-BC0D-3073A0A27D54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04031828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82BCF9-E21E-4A59-89A9-04EA4039B66B}" type="datetimeFigureOut">
              <a:rPr lang="es-ES" smtClean="0"/>
              <a:t>31/10/2025</a:t>
            </a:fld>
            <a:endParaRPr lang="es-E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7052A2-6A4C-4995-BC0D-3073A0A27D54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16800506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82BCF9-E21E-4A59-89A9-04EA4039B66B}" type="datetimeFigureOut">
              <a:rPr lang="es-ES" smtClean="0"/>
              <a:t>31/10/2025</a:t>
            </a:fld>
            <a:endParaRPr lang="es-E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7052A2-6A4C-4995-BC0D-3073A0A27D54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57219643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s-ES"/>
              <a:t>Editar el estilo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82BCF9-E21E-4A59-89A9-04EA4039B66B}" type="datetimeFigureOut">
              <a:rPr lang="es-ES" smtClean="0"/>
              <a:t>31/10/2025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7052A2-6A4C-4995-BC0D-3073A0A27D54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67843690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s-ES"/>
              <a:t>Haga clic en el icono para agregar una ima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s-ES"/>
              <a:t>Editar el estilo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82BCF9-E21E-4A59-89A9-04EA4039B66B}" type="datetimeFigureOut">
              <a:rPr lang="es-ES" smtClean="0"/>
              <a:t>31/10/2025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7052A2-6A4C-4995-BC0D-3073A0A27D54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67887032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682BCF9-E21E-4A59-89A9-04EA4039B66B}" type="datetimeFigureOut">
              <a:rPr lang="es-ES" smtClean="0"/>
              <a:t>31/10/2025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77052A2-6A4C-4995-BC0D-3073A0A27D54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8365899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Rectángulo 4"/>
          <p:cNvSpPr/>
          <p:nvPr/>
        </p:nvSpPr>
        <p:spPr>
          <a:xfrm>
            <a:off x="206734" y="296894"/>
            <a:ext cx="6453558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s-ES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</a:t>
            </a:r>
            <a:r>
              <a:rPr lang="es-E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Figure 5. 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Gating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trategy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for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he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nalysis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of CD8+ cells and CD8±T</a:t>
            </a:r>
            <a:r>
              <a:rPr lang="el-G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γδ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ells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y flow cytometry in PBMCs from study participants.</a:t>
            </a:r>
            <a:endParaRPr lang="es-E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121" name="Imagen 120">
            <a:extLst>
              <a:ext uri="{FF2B5EF4-FFF2-40B4-BE49-F238E27FC236}">
                <a16:creationId xmlns:a16="http://schemas.microsoft.com/office/drawing/2014/main" id="{297B8385-14C0-2A5C-0464-A77A2E7E8326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1017523"/>
            <a:ext cx="6858000" cy="845515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742355132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Tema d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Tema de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ema d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33</TotalTime>
  <Words>28</Words>
  <Application>Microsoft Office PowerPoint</Application>
  <PresentationFormat>A4 (210 x 297 mm)</PresentationFormat>
  <Paragraphs>1</Paragraphs>
  <Slides>1</Slides>
  <Notes>0</Notes>
  <HiddenSlides>0</HiddenSlides>
  <MMClips>0</MMClips>
  <ScaleCrop>false</ScaleCrop>
  <HeadingPairs>
    <vt:vector size="6" baseType="variant">
      <vt:variant>
        <vt:lpstr>Fuentes usadas</vt:lpstr>
      </vt:variant>
      <vt:variant>
        <vt:i4>4</vt:i4>
      </vt:variant>
      <vt:variant>
        <vt:lpstr>Tema</vt:lpstr>
      </vt:variant>
      <vt:variant>
        <vt:i4>1</vt:i4>
      </vt:variant>
      <vt:variant>
        <vt:lpstr>Títulos de diapositiva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Tema de Office</vt:lpstr>
      <vt:lpstr>Presentación de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Clara Sánchez Menéndez</dc:creator>
  <cp:lastModifiedBy>Maria Teresa Coiras Lopez</cp:lastModifiedBy>
  <cp:revision>13</cp:revision>
  <dcterms:created xsi:type="dcterms:W3CDTF">2025-10-23T08:08:58Z</dcterms:created>
  <dcterms:modified xsi:type="dcterms:W3CDTF">2025-10-31T15:00:24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MSIP_Label_b7e58c13-ab4c-4d1d-90e8-b065a0b05dbd_Enabled">
    <vt:lpwstr>true</vt:lpwstr>
  </property>
  <property fmtid="{D5CDD505-2E9C-101B-9397-08002B2CF9AE}" pid="3" name="MSIP_Label_b7e58c13-ab4c-4d1d-90e8-b065a0b05dbd_SetDate">
    <vt:lpwstr>2025-10-30T21:06:36Z</vt:lpwstr>
  </property>
  <property fmtid="{D5CDD505-2E9C-101B-9397-08002B2CF9AE}" pid="4" name="MSIP_Label_b7e58c13-ab4c-4d1d-90e8-b065a0b05dbd_Method">
    <vt:lpwstr>Standard</vt:lpwstr>
  </property>
  <property fmtid="{D5CDD505-2E9C-101B-9397-08002B2CF9AE}" pid="5" name="MSIP_Label_b7e58c13-ab4c-4d1d-90e8-b065a0b05dbd_Name">
    <vt:lpwstr>Uso Interno</vt:lpwstr>
  </property>
  <property fmtid="{D5CDD505-2E9C-101B-9397-08002B2CF9AE}" pid="6" name="MSIP_Label_b7e58c13-ab4c-4d1d-90e8-b065a0b05dbd_SiteId">
    <vt:lpwstr>cfab0009-84b7-4397-a0f8-f77cdf1579c1</vt:lpwstr>
  </property>
  <property fmtid="{D5CDD505-2E9C-101B-9397-08002B2CF9AE}" pid="7" name="MSIP_Label_b7e58c13-ab4c-4d1d-90e8-b065a0b05dbd_ActionId">
    <vt:lpwstr>672eb7a8-e227-4fd6-929c-8237b6216491</vt:lpwstr>
  </property>
  <property fmtid="{D5CDD505-2E9C-101B-9397-08002B2CF9AE}" pid="8" name="MSIP_Label_b7e58c13-ab4c-4d1d-90e8-b065a0b05dbd_ContentBits">
    <vt:lpwstr>0</vt:lpwstr>
  </property>
  <property fmtid="{D5CDD505-2E9C-101B-9397-08002B2CF9AE}" pid="9" name="MSIP_Label_b7e58c13-ab4c-4d1d-90e8-b065a0b05dbd_Tag">
    <vt:lpwstr>10, 3, 0, 1</vt:lpwstr>
  </property>
</Properties>
</file>